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1100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12"/>
    <p:restoredTop sz="94694"/>
  </p:normalViewPr>
  <p:slideViewPr>
    <p:cSldViewPr>
      <p:cViewPr varScale="1">
        <p:scale>
          <a:sx n="121" d="100"/>
          <a:sy n="121" d="100"/>
        </p:scale>
        <p:origin x="2136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A24CC8-50A5-9847-A40A-47E530C5C311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B055B7-7652-2C44-92F0-59E05B72CBF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39686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06139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785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59146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5234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82440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5761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97529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10518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60763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0060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50745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C0121-DA98-49CC-B337-5F65ADAB4667}" type="datetimeFigureOut">
              <a:rPr lang="es-MX" smtClean="0"/>
              <a:t>13/10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794D8-9199-4E49-B718-D9894652896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15526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E6DFF067-D105-C7B4-F06A-595710539F8A}"/>
              </a:ext>
            </a:extLst>
          </p:cNvPr>
          <p:cNvSpPr txBox="1"/>
          <p:nvPr/>
        </p:nvSpPr>
        <p:spPr>
          <a:xfrm>
            <a:off x="478887" y="5359882"/>
            <a:ext cx="820026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Plasmid profile of the hypermucoviscous and virulent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. michiganensis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273. Lines: 1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0192 was used as molecular size maker; 2, Hypervirulent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. pneumoniae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4660,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he non-hypermucoviscous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. pneumoniae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9458 (absent of plasmids) and 4, Hypervirulent-hypermucoviscous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. michiganensis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273. Abbreviation: Chr. Bacterial chromosome.</a:t>
            </a:r>
            <a:endParaRPr lang="es-MX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Imagen 1077283303">
            <a:extLst>
              <a:ext uri="{FF2B5EF4-FFF2-40B4-BE49-F238E27FC236}">
                <a16:creationId xmlns:a16="http://schemas.microsoft.com/office/drawing/2014/main" id="{406A42F8-C6F1-EDCA-D19D-C18BBD68B6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59" t="13301" r="72653" b="67569"/>
          <a:stretch>
            <a:fillRect/>
          </a:stretch>
        </p:blipFill>
        <p:spPr bwMode="auto">
          <a:xfrm>
            <a:off x="3325776" y="1288497"/>
            <a:ext cx="2114550" cy="3970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D392DC5A-16E6-DF16-8A43-F41347C576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9418" y="1747171"/>
            <a:ext cx="1185093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MX" altLang="es-MX" sz="14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4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75C46B5A-BCA5-DF72-E36A-2015F4F25A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09481" y="2244151"/>
            <a:ext cx="1066105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MX" altLang="es-MX" sz="1400" b="0" i="0" u="none" strike="noStrike" cap="none" normalizeH="0" baseline="0" dirty="0">
              <a:ln>
                <a:noFill/>
              </a:ln>
              <a:solidFill>
                <a:srgbClr val="222A35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400" b="0" i="0" u="none" strike="noStrike" cap="none" normalizeH="0" baseline="0" dirty="0">
                <a:ln>
                  <a:noFill/>
                </a:ln>
                <a:solidFill>
                  <a:srgbClr val="222A3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6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C0CAFFA2-516B-82CB-1FE4-3BA6AA4D92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0556" y="2756977"/>
            <a:ext cx="106293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MX" altLang="es-MX" sz="1400" b="0" i="0" u="none" strike="noStrike" cap="none" normalizeH="0" baseline="0" dirty="0">
              <a:ln>
                <a:noFill/>
              </a:ln>
              <a:solidFill>
                <a:srgbClr val="222A35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400" b="0" i="0" u="none" strike="noStrike" cap="none" normalizeH="0" baseline="0" dirty="0">
                <a:ln>
                  <a:noFill/>
                </a:ln>
                <a:solidFill>
                  <a:srgbClr val="222A3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8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" name="CuadroTexto 12">
            <a:extLst>
              <a:ext uri="{FF2B5EF4-FFF2-40B4-BE49-F238E27FC236}">
                <a16:creationId xmlns:a16="http://schemas.microsoft.com/office/drawing/2014/main" id="{4BC96A31-7AF3-8BDA-D684-DCDBB9C747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5862" y="904218"/>
            <a:ext cx="317500" cy="352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CuadroTexto 13">
            <a:extLst>
              <a:ext uri="{FF2B5EF4-FFF2-40B4-BE49-F238E27FC236}">
                <a16:creationId xmlns:a16="http://schemas.microsoft.com/office/drawing/2014/main" id="{0BFEF958-1E2B-4837-DB22-DDBBE0C264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85536" y="904218"/>
            <a:ext cx="346075" cy="352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CuadroTexto 14">
            <a:extLst>
              <a:ext uri="{FF2B5EF4-FFF2-40B4-BE49-F238E27FC236}">
                <a16:creationId xmlns:a16="http://schemas.microsoft.com/office/drawing/2014/main" id="{99F65EFA-3C36-BF68-72E2-CF7A4EC089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4719" y="899574"/>
            <a:ext cx="32711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CuadroTexto 15">
            <a:extLst>
              <a:ext uri="{FF2B5EF4-FFF2-40B4-BE49-F238E27FC236}">
                <a16:creationId xmlns:a16="http://schemas.microsoft.com/office/drawing/2014/main" id="{9E9CCF7E-2A5C-F603-8460-5FB16D65ED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1787" y="918957"/>
            <a:ext cx="568325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CuadroTexto 19">
            <a:extLst>
              <a:ext uri="{FF2B5EF4-FFF2-40B4-BE49-F238E27FC236}">
                <a16:creationId xmlns:a16="http://schemas.microsoft.com/office/drawing/2014/main" id="{BD211663-EB61-EE5B-EE7C-D7065000C9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3247" y="1022596"/>
            <a:ext cx="504056" cy="6353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MX" altLang="es-MX" sz="14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b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32" name="Conector recto 31">
            <a:extLst>
              <a:ext uri="{FF2B5EF4-FFF2-40B4-BE49-F238E27FC236}">
                <a16:creationId xmlns:a16="http://schemas.microsoft.com/office/drawing/2014/main" id="{3C4DF68A-3E10-B1D6-EFA4-51FE15D69802}"/>
              </a:ext>
            </a:extLst>
          </p:cNvPr>
          <p:cNvCxnSpPr>
            <a:cxnSpLocks/>
          </p:cNvCxnSpPr>
          <p:nvPr/>
        </p:nvCxnSpPr>
        <p:spPr>
          <a:xfrm flipH="1">
            <a:off x="3075586" y="2120106"/>
            <a:ext cx="2501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id="{43B4FE2D-4236-56EC-20B9-98052C6C4D4D}"/>
              </a:ext>
            </a:extLst>
          </p:cNvPr>
          <p:cNvCxnSpPr>
            <a:cxnSpLocks/>
          </p:cNvCxnSpPr>
          <p:nvPr/>
        </p:nvCxnSpPr>
        <p:spPr>
          <a:xfrm flipH="1">
            <a:off x="3075586" y="2636399"/>
            <a:ext cx="2501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id="{52140C8E-9AC0-3EA6-1FB5-B9DF625E27CC}"/>
              </a:ext>
            </a:extLst>
          </p:cNvPr>
          <p:cNvCxnSpPr>
            <a:cxnSpLocks/>
          </p:cNvCxnSpPr>
          <p:nvPr/>
        </p:nvCxnSpPr>
        <p:spPr>
          <a:xfrm flipH="1">
            <a:off x="3075586" y="3140968"/>
            <a:ext cx="2501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01C2C04E-8A3D-E742-0578-5350ADE8935E}"/>
              </a:ext>
            </a:extLst>
          </p:cNvPr>
          <p:cNvCxnSpPr>
            <a:cxnSpLocks/>
          </p:cNvCxnSpPr>
          <p:nvPr/>
        </p:nvCxnSpPr>
        <p:spPr>
          <a:xfrm flipH="1">
            <a:off x="3078726" y="4437112"/>
            <a:ext cx="2501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 Box 12">
            <a:extLst>
              <a:ext uri="{FF2B5EF4-FFF2-40B4-BE49-F238E27FC236}">
                <a16:creationId xmlns:a16="http://schemas.microsoft.com/office/drawing/2014/main" id="{8F6E3434-D5E3-F47D-A2CB-0A43D6EF21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7546" y="4058429"/>
            <a:ext cx="883188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MX" altLang="es-MX" sz="1400" b="0" i="0" u="none" strike="noStrike" cap="none" normalizeH="0" baseline="0" dirty="0">
              <a:ln>
                <a:noFill/>
              </a:ln>
              <a:solidFill>
                <a:srgbClr val="222A35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MX" altLang="es-MX" sz="1400" b="0" i="0" u="none" strike="noStrike" cap="none" normalizeH="0" baseline="0" dirty="0">
                <a:ln>
                  <a:noFill/>
                </a:ln>
                <a:solidFill>
                  <a:srgbClr val="222A3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r</a:t>
            </a:r>
            <a:endParaRPr kumimoji="0" lang="es-MX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23557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1</TotalTime>
  <Words>77</Words>
  <Application>Microsoft Macintosh PowerPoint</Application>
  <PresentationFormat>Presentación en pantalla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ex</dc:creator>
  <cp:lastModifiedBy>Jesus Ulises Garza Ramos</cp:lastModifiedBy>
  <cp:revision>32</cp:revision>
  <dcterms:created xsi:type="dcterms:W3CDTF">2023-07-11T16:11:18Z</dcterms:created>
  <dcterms:modified xsi:type="dcterms:W3CDTF">2023-10-13T18:31:05Z</dcterms:modified>
</cp:coreProperties>
</file>